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6740EA-6B75-48D7-84EB-A8012C7F024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1031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0B9620-F9DC-4CA7-B2A8-F89B26C4920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24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152C8-A65A-4CD7-B636-3C1C1D6A4A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2647B-54FE-4E23-B94B-80A83CCC14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02895-3EBD-433B-B2F6-A59B2619D7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48177-D6D6-40AB-BFA4-335ED973F7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425A7-D424-465E-B90A-0B3EBE1218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9DEDE7-76BA-4CFE-9FF3-2B7E094BD7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EB40E-1F4B-4175-BE6B-B48CD54E49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37990-A1C1-4E99-88A3-B69932126B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3E3A2-EB03-4FFE-8BC8-49A14EF104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0E766-155E-4DBF-AB65-23E3E4EF3D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F6DF29-B5FF-447A-8D3B-D6A35C8E61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34E49-1B94-47F0-93FF-C071DE271C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58BA6A-3E7C-4535-8937-C814936F16F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75960" y="151920"/>
            <a:ext cx="6629400" cy="685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3: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duction of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PS hypersensitivity in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. acnes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rimed TLR2/TLR9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/- ,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LR4/TLR9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nd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TLR5/TLR9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m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5" descr="Fig.S3B TNF TLR2-9.tif"/>
          <p:cNvPicPr/>
          <p:nvPr/>
        </p:nvPicPr>
        <p:blipFill>
          <a:blip r:embed="rId1"/>
          <a:srcRect l="3945" t="0" r="7890" b="0"/>
          <a:stretch/>
        </p:blipFill>
        <p:spPr>
          <a:xfrm>
            <a:off x="76320" y="1523880"/>
            <a:ext cx="2158920" cy="27003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7" descr="Fig.S3B TNF TLR4-9.tif"/>
          <p:cNvPicPr/>
          <p:nvPr/>
        </p:nvPicPr>
        <p:blipFill>
          <a:blip r:embed="rId2"/>
          <a:srcRect l="3969" t="0" r="7938" b="0"/>
          <a:stretch/>
        </p:blipFill>
        <p:spPr>
          <a:xfrm>
            <a:off x="2387520" y="1523880"/>
            <a:ext cx="2135160" cy="27003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8" descr="Fig.S3B TNF TLR5-9vsTLR9.tif"/>
          <p:cNvPicPr/>
          <p:nvPr/>
        </p:nvPicPr>
        <p:blipFill>
          <a:blip r:embed="rId3"/>
          <a:srcRect l="3961" t="0" r="7922" b="0"/>
          <a:stretch/>
        </p:blipFill>
        <p:spPr>
          <a:xfrm>
            <a:off x="4673520" y="1523880"/>
            <a:ext cx="2148120" cy="270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3T02:37:38Z</dcterms:created>
  <dc:creator>mac165</dc:creator>
  <dc:description/>
  <dc:language>en-US</dc:language>
  <cp:lastModifiedBy>domis</cp:lastModifiedBy>
  <cp:lastPrinted>2011-01-11T23:27:35Z</cp:lastPrinted>
  <dcterms:modified xsi:type="dcterms:W3CDTF">2012-05-24T18:18:27Z</dcterms:modified>
  <cp:revision>346</cp:revision>
  <dc:subject/>
  <dc:title>PowerPoint Presentation</dc:title>
</cp:coreProperties>
</file>